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6" r:id="rId2"/>
    <p:sldId id="259" r:id="rId3"/>
    <p:sldId id="257" r:id="rId4"/>
    <p:sldId id="258" r:id="rId5"/>
  </p:sldIdLst>
  <p:sldSz cx="9906000" cy="6858000" type="A4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99" d="100"/>
          <a:sy n="99" d="100"/>
        </p:scale>
        <p:origin x="672" y="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01C80F-E852-45F2-B0A9-25D5C44E5981}" type="datetimeFigureOut">
              <a:rPr lang="zh-CN" altLang="en-US" smtClean="0"/>
              <a:t>2023/6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F28E81-D70F-49F6-89D1-7DDFE7367E3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622646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01C80F-E852-45F2-B0A9-25D5C44E5981}" type="datetimeFigureOut">
              <a:rPr lang="zh-CN" altLang="en-US" smtClean="0"/>
              <a:t>2023/6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F28E81-D70F-49F6-89D1-7DDFE7367E3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472684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01C80F-E852-45F2-B0A9-25D5C44E5981}" type="datetimeFigureOut">
              <a:rPr lang="zh-CN" altLang="en-US" smtClean="0"/>
              <a:t>2023/6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F28E81-D70F-49F6-89D1-7DDFE7367E3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792792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01C80F-E852-45F2-B0A9-25D5C44E5981}" type="datetimeFigureOut">
              <a:rPr lang="zh-CN" altLang="en-US" smtClean="0"/>
              <a:t>2023/6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F28E81-D70F-49F6-89D1-7DDFE7367E3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191212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01C80F-E852-45F2-B0A9-25D5C44E5981}" type="datetimeFigureOut">
              <a:rPr lang="zh-CN" altLang="en-US" smtClean="0"/>
              <a:t>2023/6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F28E81-D70F-49F6-89D1-7DDFE7367E3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623346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01C80F-E852-45F2-B0A9-25D5C44E5981}" type="datetimeFigureOut">
              <a:rPr lang="zh-CN" altLang="en-US" smtClean="0"/>
              <a:t>2023/6/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F28E81-D70F-49F6-89D1-7DDFE7367E3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141759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01C80F-E852-45F2-B0A9-25D5C44E5981}" type="datetimeFigureOut">
              <a:rPr lang="zh-CN" altLang="en-US" smtClean="0"/>
              <a:t>2023/6/5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F28E81-D70F-49F6-89D1-7DDFE7367E3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638920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01C80F-E852-45F2-B0A9-25D5C44E5981}" type="datetimeFigureOut">
              <a:rPr lang="zh-CN" altLang="en-US" smtClean="0"/>
              <a:t>2023/6/5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F28E81-D70F-49F6-89D1-7DDFE7367E3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358086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01C80F-E852-45F2-B0A9-25D5C44E5981}" type="datetimeFigureOut">
              <a:rPr lang="zh-CN" altLang="en-US" smtClean="0"/>
              <a:t>2023/6/5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F28E81-D70F-49F6-89D1-7DDFE7367E3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478747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01C80F-E852-45F2-B0A9-25D5C44E5981}" type="datetimeFigureOut">
              <a:rPr lang="zh-CN" altLang="en-US" smtClean="0"/>
              <a:t>2023/6/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F28E81-D70F-49F6-89D1-7DDFE7367E3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281949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01C80F-E852-45F2-B0A9-25D5C44E5981}" type="datetimeFigureOut">
              <a:rPr lang="zh-CN" altLang="en-US" smtClean="0"/>
              <a:t>2023/6/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F28E81-D70F-49F6-89D1-7DDFE7367E3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522340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01C80F-E852-45F2-B0A9-25D5C44E5981}" type="datetimeFigureOut">
              <a:rPr lang="zh-CN" altLang="en-US" smtClean="0"/>
              <a:t>2023/6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F28E81-D70F-49F6-89D1-7DDFE7367E3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017766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文本框 6">
            <a:extLst>
              <a:ext uri="{FF2B5EF4-FFF2-40B4-BE49-F238E27FC236}">
                <a16:creationId xmlns:a16="http://schemas.microsoft.com/office/drawing/2014/main" id="{08051F99-4C2D-E361-39B2-9E28B27137A9}"/>
              </a:ext>
            </a:extLst>
          </p:cNvPr>
          <p:cNvSpPr txBox="1"/>
          <p:nvPr/>
        </p:nvSpPr>
        <p:spPr>
          <a:xfrm>
            <a:off x="120315" y="0"/>
            <a:ext cx="31330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4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FA3F76D0-E6EE-E1CD-E492-0C4E1A67DCC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73480" y="381000"/>
            <a:ext cx="7559040" cy="6096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8805815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文本框 6">
            <a:extLst>
              <a:ext uri="{FF2B5EF4-FFF2-40B4-BE49-F238E27FC236}">
                <a16:creationId xmlns:a16="http://schemas.microsoft.com/office/drawing/2014/main" id="{08051F99-4C2D-E361-39B2-9E28B27137A9}"/>
              </a:ext>
            </a:extLst>
          </p:cNvPr>
          <p:cNvSpPr txBox="1"/>
          <p:nvPr/>
        </p:nvSpPr>
        <p:spPr>
          <a:xfrm>
            <a:off x="120315" y="0"/>
            <a:ext cx="31330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5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F36189EB-8E7E-C850-5839-4C46B1FA352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73480" y="1143000"/>
            <a:ext cx="7559040" cy="4572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4975312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文本框 6">
            <a:extLst>
              <a:ext uri="{FF2B5EF4-FFF2-40B4-BE49-F238E27FC236}">
                <a16:creationId xmlns:a16="http://schemas.microsoft.com/office/drawing/2014/main" id="{08051F99-4C2D-E361-39B2-9E28B27137A9}"/>
              </a:ext>
            </a:extLst>
          </p:cNvPr>
          <p:cNvSpPr txBox="1"/>
          <p:nvPr/>
        </p:nvSpPr>
        <p:spPr>
          <a:xfrm>
            <a:off x="120315" y="0"/>
            <a:ext cx="31330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6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9D960A04-102B-1D2A-5453-FEFC402529B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73480" y="1143000"/>
            <a:ext cx="7559040" cy="4572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8124512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文本框 6">
            <a:extLst>
              <a:ext uri="{FF2B5EF4-FFF2-40B4-BE49-F238E27FC236}">
                <a16:creationId xmlns:a16="http://schemas.microsoft.com/office/drawing/2014/main" id="{08051F99-4C2D-E361-39B2-9E28B27137A9}"/>
              </a:ext>
            </a:extLst>
          </p:cNvPr>
          <p:cNvSpPr txBox="1"/>
          <p:nvPr/>
        </p:nvSpPr>
        <p:spPr>
          <a:xfrm>
            <a:off x="120315" y="0"/>
            <a:ext cx="31330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7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B44B30D2-A575-A888-19DD-80D01373C5E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73480" y="381000"/>
            <a:ext cx="7559040" cy="6096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418389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7</TotalTime>
  <Words>12</Words>
  <Application>Microsoft Office PowerPoint</Application>
  <PresentationFormat>A4 纸张(210x297 毫米)</PresentationFormat>
  <Paragraphs>4</Paragraphs>
  <Slides>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主题​​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满 金辉</dc:creator>
  <cp:lastModifiedBy>金辉 满</cp:lastModifiedBy>
  <cp:revision>5</cp:revision>
  <dcterms:created xsi:type="dcterms:W3CDTF">2023-03-20T07:21:23Z</dcterms:created>
  <dcterms:modified xsi:type="dcterms:W3CDTF">2023-06-05T10:53:35Z</dcterms:modified>
</cp:coreProperties>
</file>